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ti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1" r:id="rId2"/>
    <p:sldId id="262" r:id="rId3"/>
    <p:sldId id="263" r:id="rId4"/>
    <p:sldId id="264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岡本　由香子" initials="岡本　由香子" lastIdx="1" clrIdx="0">
    <p:extLst>
      <p:ext uri="{19B8F6BF-5375-455C-9EA6-DF929625EA0E}">
        <p15:presenceInfo xmlns:p15="http://schemas.microsoft.com/office/powerpoint/2012/main" userId="岡本　由香子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995" autoAdjust="0"/>
    <p:restoredTop sz="96318" autoAdjust="0"/>
  </p:normalViewPr>
  <p:slideViewPr>
    <p:cSldViewPr snapToGrid="0">
      <p:cViewPr>
        <p:scale>
          <a:sx n="78" d="100"/>
          <a:sy n="78" d="100"/>
        </p:scale>
        <p:origin x="3084" y="-5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emf"/><Relationship Id="rId1" Type="http://schemas.openxmlformats.org/officeDocument/2006/relationships/image" Target="../media/image8.emf"/><Relationship Id="rId4" Type="http://schemas.openxmlformats.org/officeDocument/2006/relationships/image" Target="../media/image1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206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51987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86736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0033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83435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43165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38131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99829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225448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50115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31207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4F0AE99-B7D2-4C0B-8511-AA157CA46602}" type="datetimeFigureOut">
              <a:rPr kumimoji="1" lang="ja-JP" altLang="en-US" smtClean="0"/>
              <a:t>2025/6/2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CA94D5-5E34-47DB-A05E-B00B35A63C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84025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7.ti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oleObject" Target="../embeddings/oleObject4.bin"/><Relationship Id="rId7" Type="http://schemas.openxmlformats.org/officeDocument/2006/relationships/oleObject" Target="../embeddings/oleObject6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5.bin"/><Relationship Id="rId10" Type="http://schemas.openxmlformats.org/officeDocument/2006/relationships/image" Target="../media/image11.emf"/><Relationship Id="rId4" Type="http://schemas.openxmlformats.org/officeDocument/2006/relationships/image" Target="../media/image8.emf"/><Relationship Id="rId9" Type="http://schemas.openxmlformats.org/officeDocument/2006/relationships/oleObject" Target="../embeddings/oleObject7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5C5B8C95-4CED-4B90-9BCD-9BE2104E88BF}"/>
              </a:ext>
            </a:extLst>
          </p:cNvPr>
          <p:cNvSpPr txBox="1"/>
          <p:nvPr/>
        </p:nvSpPr>
        <p:spPr>
          <a:xfrm>
            <a:off x="4024162" y="9444445"/>
            <a:ext cx="28338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 Ishikawa et al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EC82FEB-3E16-44F7-9253-FD3C09FE536E}"/>
              </a:ext>
            </a:extLst>
          </p:cNvPr>
          <p:cNvSpPr txBox="1"/>
          <p:nvPr/>
        </p:nvSpPr>
        <p:spPr>
          <a:xfrm>
            <a:off x="725790" y="779416"/>
            <a:ext cx="2833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図 5">
            <a:extLst>
              <a:ext uri="{FF2B5EF4-FFF2-40B4-BE49-F238E27FC236}">
                <a16:creationId xmlns:a16="http://schemas.microsoft.com/office/drawing/2014/main" id="{DF56D019-9CCB-4EA3-8EC4-0B944FFE480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75706" y="1646615"/>
            <a:ext cx="2710544" cy="2032908"/>
          </a:xfrm>
          <a:prstGeom prst="rect">
            <a:avLst/>
          </a:prstGeom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062F6AED-0DBD-4A68-8A20-5971F220AA31}"/>
              </a:ext>
            </a:extLst>
          </p:cNvPr>
          <p:cNvSpPr txBox="1"/>
          <p:nvPr/>
        </p:nvSpPr>
        <p:spPr>
          <a:xfrm>
            <a:off x="1805953" y="1213015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CA72BB6C-8F7F-485F-80AA-DC34F93CFE75}"/>
              </a:ext>
            </a:extLst>
          </p:cNvPr>
          <p:cNvSpPr txBox="1"/>
          <p:nvPr/>
        </p:nvSpPr>
        <p:spPr>
          <a:xfrm>
            <a:off x="4858104" y="1213015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52B358C4-A7B1-4CFD-B33D-3A377CB20823}"/>
              </a:ext>
            </a:extLst>
          </p:cNvPr>
          <p:cNvSpPr txBox="1"/>
          <p:nvPr/>
        </p:nvSpPr>
        <p:spPr>
          <a:xfrm>
            <a:off x="811729" y="4214336"/>
            <a:ext cx="5495798" cy="22467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1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Examples of images of (A) nerve elongation measurements of DRG and (B) fluorescence area measurement. </a:t>
            </a: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Neurites of DRG cells were measured from the edge of the nucleus to the nerve endings</a:t>
            </a:r>
            <a:r>
              <a:rPr lang="ja-JP" altLang="en-US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. </a:t>
            </a: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o measure immunofluorescence staining, a region of interest (ROI) was manually defined to exclude non-tissue areas. Within the ROI, the fluorescent signal was binarized, and the area of fluorescence was calculated as a percentage of the total ROI area (B).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pSp>
        <p:nvGrpSpPr>
          <p:cNvPr id="16" name="グループ化 15">
            <a:extLst>
              <a:ext uri="{FF2B5EF4-FFF2-40B4-BE49-F238E27FC236}">
                <a16:creationId xmlns:a16="http://schemas.microsoft.com/office/drawing/2014/main" id="{769429E5-BA0B-452E-A63F-8574C17FAC22}"/>
              </a:ext>
            </a:extLst>
          </p:cNvPr>
          <p:cNvGrpSpPr/>
          <p:nvPr/>
        </p:nvGrpSpPr>
        <p:grpSpPr>
          <a:xfrm>
            <a:off x="725790" y="1646614"/>
            <a:ext cx="2710543" cy="2032908"/>
            <a:chOff x="-550473" y="1582347"/>
            <a:chExt cx="6858000" cy="5143500"/>
          </a:xfrm>
        </p:grpSpPr>
        <p:grpSp>
          <p:nvGrpSpPr>
            <p:cNvPr id="14" name="グループ化 13">
              <a:extLst>
                <a:ext uri="{FF2B5EF4-FFF2-40B4-BE49-F238E27FC236}">
                  <a16:creationId xmlns:a16="http://schemas.microsoft.com/office/drawing/2014/main" id="{1E66F3A5-1BB0-4509-9209-5A6B984639BE}"/>
                </a:ext>
              </a:extLst>
            </p:cNvPr>
            <p:cNvGrpSpPr/>
            <p:nvPr/>
          </p:nvGrpSpPr>
          <p:grpSpPr>
            <a:xfrm>
              <a:off x="-550473" y="1582347"/>
              <a:ext cx="6858000" cy="5143500"/>
              <a:chOff x="-603623" y="1560338"/>
              <a:chExt cx="6858000" cy="5143500"/>
            </a:xfrm>
          </p:grpSpPr>
          <p:pic>
            <p:nvPicPr>
              <p:cNvPr id="8" name="図 7">
                <a:extLst>
                  <a:ext uri="{FF2B5EF4-FFF2-40B4-BE49-F238E27FC236}">
                    <a16:creationId xmlns:a16="http://schemas.microsoft.com/office/drawing/2014/main" id="{9CC57B4F-2873-4AE8-BF3A-C70BDB7D5F7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-603623" y="1560338"/>
                <a:ext cx="6858000" cy="5143500"/>
              </a:xfrm>
              <a:prstGeom prst="rect">
                <a:avLst/>
              </a:prstGeom>
            </p:spPr>
          </p:pic>
          <p:sp>
            <p:nvSpPr>
              <p:cNvPr id="11" name="正方形/長方形 10">
                <a:extLst>
                  <a:ext uri="{FF2B5EF4-FFF2-40B4-BE49-F238E27FC236}">
                    <a16:creationId xmlns:a16="http://schemas.microsoft.com/office/drawing/2014/main" id="{D16113F9-AE06-4CE9-BAB2-225EF619F763}"/>
                  </a:ext>
                </a:extLst>
              </p:cNvPr>
              <p:cNvSpPr/>
              <p:nvPr/>
            </p:nvSpPr>
            <p:spPr>
              <a:xfrm>
                <a:off x="5451788" y="6540938"/>
                <a:ext cx="792378" cy="124604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</p:grpSp>
        <p:cxnSp>
          <p:nvCxnSpPr>
            <p:cNvPr id="13" name="直線コネクタ 12">
              <a:extLst>
                <a:ext uri="{FF2B5EF4-FFF2-40B4-BE49-F238E27FC236}">
                  <a16:creationId xmlns:a16="http://schemas.microsoft.com/office/drawing/2014/main" id="{133585FE-10EF-44F5-9A4D-336B39A349F2}"/>
                </a:ext>
              </a:extLst>
            </p:cNvPr>
            <p:cNvCxnSpPr/>
            <p:nvPr/>
          </p:nvCxnSpPr>
          <p:spPr>
            <a:xfrm>
              <a:off x="5510306" y="6603240"/>
              <a:ext cx="675341" cy="0"/>
            </a:xfrm>
            <a:prstGeom prst="line">
              <a:avLst/>
            </a:prstGeom>
            <a:ln w="127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3ABCFBB6-7D81-432F-BE5E-B42C84ACA2EC}"/>
              </a:ext>
            </a:extLst>
          </p:cNvPr>
          <p:cNvSpPr txBox="1"/>
          <p:nvPr/>
        </p:nvSpPr>
        <p:spPr>
          <a:xfrm>
            <a:off x="3065386" y="3495109"/>
            <a:ext cx="378630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500" dirty="0">
                <a:solidFill>
                  <a:srgbClr val="FFFF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um</a:t>
            </a:r>
            <a:endParaRPr kumimoji="1" lang="ja-JP" altLang="en-US" sz="500" dirty="0">
              <a:solidFill>
                <a:srgbClr val="FFFF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690744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C01AD0D6-C1AE-425E-BDFC-762B5F37A32D}"/>
              </a:ext>
            </a:extLst>
          </p:cNvPr>
          <p:cNvSpPr txBox="1"/>
          <p:nvPr/>
        </p:nvSpPr>
        <p:spPr>
          <a:xfrm>
            <a:off x="4024162" y="9444445"/>
            <a:ext cx="28338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 Ishikawa et al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8C9700CF-5F38-48F5-8325-E285A193D3E0}"/>
              </a:ext>
            </a:extLst>
          </p:cNvPr>
          <p:cNvSpPr txBox="1"/>
          <p:nvPr/>
        </p:nvSpPr>
        <p:spPr>
          <a:xfrm>
            <a:off x="725790" y="779416"/>
            <a:ext cx="2833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EC75D02F-1683-4E1B-A1E9-972F008331B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6890667"/>
              </p:ext>
            </p:extLst>
          </p:nvPr>
        </p:nvGraphicFramePr>
        <p:xfrm>
          <a:off x="725790" y="1710414"/>
          <a:ext cx="2535751" cy="31110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2" name="Prism 9" r:id="rId3" imgW="3142184" imgH="3854369" progId="Prism9.Document">
                  <p:embed/>
                </p:oleObj>
              </mc:Choice>
              <mc:Fallback>
                <p:oleObj name="Prism 9" r:id="rId3" imgW="3142184" imgH="3854369" progId="Prism9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2D22412C-7CC0-4B36-BCC6-DB0AB52EFC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25790" y="1710414"/>
                        <a:ext cx="2535751" cy="31110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D8816E42-5DFF-4035-AF5C-82DE9DEC0C80}"/>
              </a:ext>
            </a:extLst>
          </p:cNvPr>
          <p:cNvSpPr txBox="1"/>
          <p:nvPr/>
        </p:nvSpPr>
        <p:spPr>
          <a:xfrm>
            <a:off x="1778169" y="4399913"/>
            <a:ext cx="945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OSM(ng/ml)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オブジェクト 10">
            <a:extLst>
              <a:ext uri="{FF2B5EF4-FFF2-40B4-BE49-F238E27FC236}">
                <a16:creationId xmlns:a16="http://schemas.microsoft.com/office/drawing/2014/main" id="{61C50840-B03B-4A02-980A-53182DE4FE8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2173435"/>
              </p:ext>
            </p:extLst>
          </p:nvPr>
        </p:nvGraphicFramePr>
        <p:xfrm>
          <a:off x="3511743" y="1864530"/>
          <a:ext cx="2514600" cy="31464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3" name="Prism 9" r:id="rId5" imgW="2514107" imgH="3147026" progId="Prism9.Document">
                  <p:embed/>
                </p:oleObj>
              </mc:Choice>
              <mc:Fallback>
                <p:oleObj name="Prism 9" r:id="rId5" imgW="2514107" imgH="3147026" progId="Prism9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8119638C-1A43-4006-9BA5-8F894240E87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11743" y="1864530"/>
                        <a:ext cx="2514600" cy="31464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7667E00-7169-4E0C-90B9-29B823339CF4}"/>
              </a:ext>
            </a:extLst>
          </p:cNvPr>
          <p:cNvSpPr txBox="1"/>
          <p:nvPr/>
        </p:nvSpPr>
        <p:spPr>
          <a:xfrm>
            <a:off x="427078" y="4953000"/>
            <a:ext cx="5878029" cy="28931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2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A) Measurements of nerve elongation of DRG cells at different OSM concentrations: control, and 1, 10, 100, and 200 ng/mL OSM respectively. For each group, 9–11 random fields were imaged, and the five longest neurites per field were measured. The experiment was repeated in </a:t>
            </a:r>
            <a:r>
              <a:rPr lang="en-US" altLang="ja-JP" sz="14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dupilicate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, and the data were combined for analysis. Data are presented as the mean ± standard error (SE), ****p&lt;0.0001, ns: not significant.</a:t>
            </a:r>
            <a:r>
              <a:rPr lang="ja-JP" altLang="en-US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SM: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ncostatin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.</a:t>
            </a:r>
            <a:endParaRPr lang="en-US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(B) The expression level of OSMRβ in DRG neurons of HR-1 mice was analyzed by </a:t>
            </a:r>
            <a:r>
              <a:rPr lang="en-US" altLang="ja-JP" sz="14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qRT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PCR. It was further shown that the expression level of OSMRβ increased 3 hours after OSM administration. The experiment was repeated three times. 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SM: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ncostatin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; OSMR: </a:t>
            </a:r>
            <a:r>
              <a:rPr lang="en-US" altLang="ja-JP" sz="1400" kern="100" dirty="0" err="1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oncostatin</a:t>
            </a:r>
            <a:r>
              <a:rPr lang="en-US" altLang="ja-JP" sz="1400" kern="1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M receptor.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C4A6DFD-9D1F-40F2-846E-E776DB57DEB3}"/>
              </a:ext>
            </a:extLst>
          </p:cNvPr>
          <p:cNvSpPr txBox="1"/>
          <p:nvPr/>
        </p:nvSpPr>
        <p:spPr>
          <a:xfrm>
            <a:off x="1933544" y="1319851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93210F5-E077-4582-99A3-26B8F50C8527}"/>
              </a:ext>
            </a:extLst>
          </p:cNvPr>
          <p:cNvSpPr txBox="1"/>
          <p:nvPr/>
        </p:nvSpPr>
        <p:spPr>
          <a:xfrm>
            <a:off x="4762412" y="1319851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11739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7" name="図 26">
            <a:extLst>
              <a:ext uri="{FF2B5EF4-FFF2-40B4-BE49-F238E27FC236}">
                <a16:creationId xmlns:a16="http://schemas.microsoft.com/office/drawing/2014/main" id="{0C45C0E1-ACD0-413C-AFE3-EFED39D651A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313" t="32295" r="40922" b="62196"/>
          <a:stretch/>
        </p:blipFill>
        <p:spPr>
          <a:xfrm>
            <a:off x="2085625" y="4827327"/>
            <a:ext cx="2342773" cy="615458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17EB4565-50D6-4BFA-BC8F-9D91A9A49551}"/>
              </a:ext>
            </a:extLst>
          </p:cNvPr>
          <p:cNvSpPr txBox="1"/>
          <p:nvPr/>
        </p:nvSpPr>
        <p:spPr>
          <a:xfrm>
            <a:off x="4024162" y="9444445"/>
            <a:ext cx="28338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 Ishikawa et al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ABDEE4EB-DC2B-43C9-804B-28B949A5F110}"/>
              </a:ext>
            </a:extLst>
          </p:cNvPr>
          <p:cNvSpPr txBox="1"/>
          <p:nvPr/>
        </p:nvSpPr>
        <p:spPr>
          <a:xfrm>
            <a:off x="725790" y="779416"/>
            <a:ext cx="2833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4BCF367-E0C5-4296-BBBC-39B2E344461D}"/>
              </a:ext>
            </a:extLst>
          </p:cNvPr>
          <p:cNvSpPr txBox="1"/>
          <p:nvPr/>
        </p:nvSpPr>
        <p:spPr>
          <a:xfrm>
            <a:off x="1463253" y="5917401"/>
            <a:ext cx="68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β-actin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1DD0CE6B-0AD4-4EF1-A0AD-D75D7478FA11}"/>
              </a:ext>
            </a:extLst>
          </p:cNvPr>
          <p:cNvSpPr txBox="1"/>
          <p:nvPr/>
        </p:nvSpPr>
        <p:spPr>
          <a:xfrm>
            <a:off x="2415111" y="4567305"/>
            <a:ext cx="87103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Parental</a:t>
            </a:r>
            <a:r>
              <a: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ells 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8" name="図 27">
            <a:extLst>
              <a:ext uri="{FF2B5EF4-FFF2-40B4-BE49-F238E27FC236}">
                <a16:creationId xmlns:a16="http://schemas.microsoft.com/office/drawing/2014/main" id="{1889D3EC-FE8E-47A7-9631-5645F6ECD0D2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190" t="45226" r="42234" b="49722"/>
          <a:stretch/>
        </p:blipFill>
        <p:spPr>
          <a:xfrm>
            <a:off x="2327412" y="5873576"/>
            <a:ext cx="2123847" cy="550806"/>
          </a:xfrm>
          <a:prstGeom prst="rect">
            <a:avLst/>
          </a:prstGeom>
        </p:spPr>
      </p:pic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5651EA2B-9F70-42E9-BDC0-7B213706625D}"/>
              </a:ext>
            </a:extLst>
          </p:cNvPr>
          <p:cNvSpPr txBox="1"/>
          <p:nvPr/>
        </p:nvSpPr>
        <p:spPr>
          <a:xfrm>
            <a:off x="1464115" y="4996557"/>
            <a:ext cx="6801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OSMR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DCF2412A-B1A5-4BDF-BF84-1459C0B1DA32}"/>
              </a:ext>
            </a:extLst>
          </p:cNvPr>
          <p:cNvSpPr txBox="1"/>
          <p:nvPr/>
        </p:nvSpPr>
        <p:spPr>
          <a:xfrm>
            <a:off x="3162085" y="4574423"/>
            <a:ext cx="5284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Mock</a:t>
            </a:r>
          </a:p>
          <a:p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604A6B0-966B-4D41-AEBC-D203659A0902}"/>
              </a:ext>
            </a:extLst>
          </p:cNvPr>
          <p:cNvSpPr txBox="1"/>
          <p:nvPr/>
        </p:nvSpPr>
        <p:spPr>
          <a:xfrm>
            <a:off x="3531382" y="4582364"/>
            <a:ext cx="8970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OSMRβ</a:t>
            </a:r>
            <a:r>
              <a:rPr kumimoji="1" lang="ja-JP" altLang="en-US" sz="900" dirty="0">
                <a:latin typeface="Arial" panose="020B0604020202020204" pitchFamily="34" charset="0"/>
                <a:cs typeface="Arial" panose="020B0604020202020204" pitchFamily="34" charset="0"/>
              </a:rPr>
              <a:t>＋</a:t>
            </a:r>
            <a:endParaRPr kumimoji="1" lang="en-US" altLang="ja-JP" sz="9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9C8EC7F-C1FC-483A-A1EE-9711A7CE39D4}"/>
              </a:ext>
            </a:extLst>
          </p:cNvPr>
          <p:cNvSpPr txBox="1"/>
          <p:nvPr/>
        </p:nvSpPr>
        <p:spPr>
          <a:xfrm>
            <a:off x="890016" y="1369697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E0BCE89B-67D4-4022-BC80-347F0AAD0506}"/>
              </a:ext>
            </a:extLst>
          </p:cNvPr>
          <p:cNvSpPr txBox="1"/>
          <p:nvPr/>
        </p:nvSpPr>
        <p:spPr>
          <a:xfrm>
            <a:off x="887480" y="4233756"/>
            <a:ext cx="4924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2AD179C-C710-4367-B72D-FFB4254B72DF}"/>
              </a:ext>
            </a:extLst>
          </p:cNvPr>
          <p:cNvSpPr txBox="1"/>
          <p:nvPr/>
        </p:nvSpPr>
        <p:spPr>
          <a:xfrm>
            <a:off x="583519" y="6905158"/>
            <a:ext cx="5592987" cy="95410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3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Parental cells, control vector transfected cells, and OSMRβ overexpressing cells are shown for OSMR expression. (A) </a:t>
            </a:r>
            <a:r>
              <a:rPr lang="en-US" altLang="ja-JP" sz="1400" kern="100" dirty="0" err="1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qRT</a:t>
            </a:r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-PCR, (B) Western Blot.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  <p:graphicFrame>
        <p:nvGraphicFramePr>
          <p:cNvPr id="17" name="オブジェクト 16">
            <a:extLst>
              <a:ext uri="{FF2B5EF4-FFF2-40B4-BE49-F238E27FC236}">
                <a16:creationId xmlns:a16="http://schemas.microsoft.com/office/drawing/2014/main" id="{52C17363-652C-45ED-97B2-C4E5EC983D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8060982"/>
              </p:ext>
            </p:extLst>
          </p:nvPr>
        </p:nvGraphicFramePr>
        <p:xfrm>
          <a:off x="1626726" y="1517135"/>
          <a:ext cx="3525218" cy="252662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104" name="Prism 9" r:id="rId5" imgW="3805194" imgH="2727447" progId="Prism9.Document">
                  <p:embed/>
                </p:oleObj>
              </mc:Choice>
              <mc:Fallback>
                <p:oleObj name="Prism 9" r:id="rId5" imgW="3805194" imgH="2727447" progId="Prism9.Document">
                  <p:embed/>
                  <p:pic>
                    <p:nvPicPr>
                      <p:cNvPr id="2" name="オブジェクト 1">
                        <a:extLst>
                          <a:ext uri="{FF2B5EF4-FFF2-40B4-BE49-F238E27FC236}">
                            <a16:creationId xmlns:a16="http://schemas.microsoft.com/office/drawing/2014/main" id="{959BC658-BFFD-4592-99BA-3AF5F7C408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626726" y="1517135"/>
                        <a:ext cx="3525218" cy="252662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6958860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BDE84AA-9DA1-4161-814B-E1693EA7DC06}"/>
              </a:ext>
            </a:extLst>
          </p:cNvPr>
          <p:cNvSpPr txBox="1"/>
          <p:nvPr/>
        </p:nvSpPr>
        <p:spPr>
          <a:xfrm>
            <a:off x="4024162" y="9444445"/>
            <a:ext cx="283383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Supplementary material Ishikawa et al.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705AFAB-5FD5-4AF4-8330-3DE5E95E20B1}"/>
              </a:ext>
            </a:extLst>
          </p:cNvPr>
          <p:cNvSpPr txBox="1"/>
          <p:nvPr/>
        </p:nvSpPr>
        <p:spPr>
          <a:xfrm>
            <a:off x="725790" y="779416"/>
            <a:ext cx="28338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E904650F-8925-457C-8F3C-8832EFF7FDA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83903523"/>
              </p:ext>
            </p:extLst>
          </p:nvPr>
        </p:nvGraphicFramePr>
        <p:xfrm>
          <a:off x="1056548" y="1454013"/>
          <a:ext cx="2432775" cy="322281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6" name="Prism 9" r:id="rId3" imgW="2527793" imgH="3347992" progId="Prism9.Document">
                  <p:embed/>
                </p:oleObj>
              </mc:Choice>
              <mc:Fallback>
                <p:oleObj name="Prism 9" r:id="rId3" imgW="2527793" imgH="3347992" progId="Prism9.Document">
                  <p:embed/>
                  <p:pic>
                    <p:nvPicPr>
                      <p:cNvPr id="11" name="オブジェクト 10">
                        <a:extLst>
                          <a:ext uri="{FF2B5EF4-FFF2-40B4-BE49-F238E27FC236}">
                            <a16:creationId xmlns:a16="http://schemas.microsoft.com/office/drawing/2014/main" id="{C90C2B5A-E0D0-4E53-84C9-1B36C7853A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56548" y="1454013"/>
                        <a:ext cx="2432775" cy="322281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C62DCF99-F90B-4739-928A-1E2DB4434C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61453341"/>
              </p:ext>
            </p:extLst>
          </p:nvPr>
        </p:nvGraphicFramePr>
        <p:xfrm>
          <a:off x="3052763" y="1642632"/>
          <a:ext cx="2362200" cy="3028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7" name="Prism 9" r:id="rId5" imgW="2454685" imgH="3147026" progId="Prism9.Document">
                  <p:embed/>
                </p:oleObj>
              </mc:Choice>
              <mc:Fallback>
                <p:oleObj name="Prism 9" r:id="rId5" imgW="2454685" imgH="3147026" progId="Prism9.Document">
                  <p:embed/>
                  <p:pic>
                    <p:nvPicPr>
                      <p:cNvPr id="12" name="オブジェクト 11">
                        <a:extLst>
                          <a:ext uri="{FF2B5EF4-FFF2-40B4-BE49-F238E27FC236}">
                            <a16:creationId xmlns:a16="http://schemas.microsoft.com/office/drawing/2014/main" id="{2CAFFCEE-1BD3-4D90-9268-5441751D8E6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052763" y="1642632"/>
                        <a:ext cx="2362200" cy="3028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97C4417C-9340-4033-B3D4-596FB88824F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53213088"/>
              </p:ext>
            </p:extLst>
          </p:nvPr>
        </p:nvGraphicFramePr>
        <p:xfrm>
          <a:off x="1057275" y="4684115"/>
          <a:ext cx="2432050" cy="30622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8" name="Prism 9" r:id="rId7" imgW="2527793" imgH="3183402" progId="Prism9.Document">
                  <p:embed/>
                </p:oleObj>
              </mc:Choice>
              <mc:Fallback>
                <p:oleObj name="Prism 9" r:id="rId7" imgW="2527793" imgH="3183402" progId="Prism9.Document">
                  <p:embed/>
                  <p:pic>
                    <p:nvPicPr>
                      <p:cNvPr id="13" name="オブジェクト 12">
                        <a:extLst>
                          <a:ext uri="{FF2B5EF4-FFF2-40B4-BE49-F238E27FC236}">
                            <a16:creationId xmlns:a16="http://schemas.microsoft.com/office/drawing/2014/main" id="{7756BA4F-C856-41C0-907D-0F3A3ABABF2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057275" y="4684115"/>
                        <a:ext cx="2432050" cy="30622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オブジェクト 8">
            <a:extLst>
              <a:ext uri="{FF2B5EF4-FFF2-40B4-BE49-F238E27FC236}">
                <a16:creationId xmlns:a16="http://schemas.microsoft.com/office/drawing/2014/main" id="{338DCBB5-9FAA-4D0F-B0E6-E53A3BBB8BA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35446399"/>
              </p:ext>
            </p:extLst>
          </p:nvPr>
        </p:nvGraphicFramePr>
        <p:xfrm>
          <a:off x="3168650" y="4759325"/>
          <a:ext cx="2362200" cy="2932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9" name="Prism 9" r:id="rId9" imgW="2454685" imgH="3046183" progId="Prism9.Document">
                  <p:embed/>
                </p:oleObj>
              </mc:Choice>
              <mc:Fallback>
                <p:oleObj name="Prism 9" r:id="rId9" imgW="2454685" imgH="3046183" progId="Prism9.Document">
                  <p:embed/>
                  <p:pic>
                    <p:nvPicPr>
                      <p:cNvPr id="14" name="オブジェクト 13">
                        <a:extLst>
                          <a:ext uri="{FF2B5EF4-FFF2-40B4-BE49-F238E27FC236}">
                            <a16:creationId xmlns:a16="http://schemas.microsoft.com/office/drawing/2014/main" id="{3ABC64C0-2739-4A72-9780-3B47BC09947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168650" y="4759325"/>
                        <a:ext cx="2362200" cy="2932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C5164E28-BD60-4EAD-BC58-EE233B345056}"/>
              </a:ext>
            </a:extLst>
          </p:cNvPr>
          <p:cNvSpPr txBox="1"/>
          <p:nvPr/>
        </p:nvSpPr>
        <p:spPr>
          <a:xfrm>
            <a:off x="513134" y="7557109"/>
            <a:ext cx="5831732" cy="1600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Supplementary Figure 4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  <a:p>
            <a:pPr algn="just"/>
            <a:r>
              <a:rPr lang="en-US" altLang="ja-JP" sz="1400" kern="1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number and duration of scratching after subcutaneous injection of saline or OSM into the posterior neck for 1 month, followed by histamine or IL-31. A total of four mice were used per group (N=4). Histamine was observed for 30 minutes after administration and IL31 for 90 minutes after administration. Data are presented as the mean ± standard error (SE), ns: not significant.</a:t>
            </a:r>
            <a:endParaRPr lang="ja-JP" altLang="ja-JP" sz="1400" kern="100" dirty="0">
              <a:effectLst/>
              <a:latin typeface="Arial" panose="020B0604020202020204" pitchFamily="34" charset="0"/>
              <a:ea typeface="游明朝" panose="02020400000000000000" pitchFamily="18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7399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12</TotalTime>
  <Words>418</Words>
  <Application>Microsoft Office PowerPoint</Application>
  <PresentationFormat>A4 210 x 297 mm</PresentationFormat>
  <Paragraphs>32</Paragraphs>
  <Slides>4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2</vt:i4>
      </vt:variant>
      <vt:variant>
        <vt:lpstr>スライド タイトル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Office テーマ</vt:lpstr>
      <vt:lpstr>Prism 9</vt:lpstr>
      <vt:lpstr>GraphPad Prism 9 Project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岡本　由香子</dc:creator>
  <cp:lastModifiedBy>岡本　由香子</cp:lastModifiedBy>
  <cp:revision>71</cp:revision>
  <dcterms:created xsi:type="dcterms:W3CDTF">2024-09-19T02:59:17Z</dcterms:created>
  <dcterms:modified xsi:type="dcterms:W3CDTF">2025-06-20T02:35:55Z</dcterms:modified>
</cp:coreProperties>
</file>